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57" r:id="rId2"/>
    <p:sldId id="265" r:id="rId3"/>
    <p:sldId id="266" r:id="rId4"/>
    <p:sldId id="267" r:id="rId5"/>
    <p:sldId id="268" r:id="rId6"/>
    <p:sldId id="269" r:id="rId7"/>
    <p:sldId id="270" r:id="rId8"/>
    <p:sldId id="272" r:id="rId9"/>
    <p:sldId id="273" r:id="rId10"/>
    <p:sldId id="282" r:id="rId11"/>
    <p:sldId id="283" r:id="rId12"/>
    <p:sldId id="284" r:id="rId13"/>
    <p:sldId id="285" r:id="rId14"/>
    <p:sldId id="286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eba SYED" initials="DS" lastIdx="5" clrIdx="0">
    <p:extLst>
      <p:ext uri="{19B8F6BF-5375-455C-9EA6-DF929625EA0E}">
        <p15:presenceInfo xmlns:p15="http://schemas.microsoft.com/office/powerpoint/2012/main" userId="S-1-5-21-944445629-1489980678-184074267-58251" providerId="AD"/>
      </p:ext>
    </p:extLst>
  </p:cmAuthor>
  <p:cmAuthor id="2" name="Saheed Afolabi" initials="SA" lastIdx="2" clrIdx="1">
    <p:extLst>
      <p:ext uri="{19B8F6BF-5375-455C-9EA6-DF929625EA0E}">
        <p15:presenceInfo xmlns:p15="http://schemas.microsoft.com/office/powerpoint/2012/main" userId="Saheed Afolab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F5DB97-EF45-4AD9-BAD5-7BE704B9A5CC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B04200-81A6-43CE-8C61-B840088E2D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7017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D6C199-33CC-43CF-BDA4-54218F1796A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394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62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014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204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725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508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977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547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55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745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955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017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156F2-F15E-4602-BA33-37A022B27CA4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AA9A2-6F47-498B-982A-B277E5962F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12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jpeg"/><Relationship Id="rId4" Type="http://schemas.openxmlformats.org/officeDocument/2006/relationships/image" Target="../media/image31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jpeg"/><Relationship Id="rId4" Type="http://schemas.openxmlformats.org/officeDocument/2006/relationships/image" Target="../media/image35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9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2" Type="http://schemas.openxmlformats.org/officeDocument/2006/relationships/image" Target="../media/image40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tiff"/><Relationship Id="rId4" Type="http://schemas.openxmlformats.org/officeDocument/2006/relationships/image" Target="../media/image4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67000" y="1563794"/>
            <a:ext cx="6858000" cy="1790700"/>
          </a:xfrm>
        </p:spPr>
        <p:txBody>
          <a:bodyPr/>
          <a:lstStyle/>
          <a:p>
            <a:r>
              <a:rPr lang="en-US" b="1" dirty="0" smtClean="0"/>
              <a:t>SUPPLEMENTARY FIGUR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91569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84093" y="2397860"/>
            <a:ext cx="10932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information 2: Original western blots </a:t>
            </a:r>
            <a:endParaRPr lang="en-US" sz="2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7529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88721" y="195942"/>
            <a:ext cx="9431383" cy="5952239"/>
            <a:chOff x="457200" y="117566"/>
            <a:chExt cx="10593977" cy="6461690"/>
          </a:xfrm>
        </p:grpSpPr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5695" y="421426"/>
              <a:ext cx="4440342" cy="3028851"/>
            </a:xfrm>
            <a:prstGeom prst="rect">
              <a:avLst/>
            </a:prstGeom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8734" y="421426"/>
              <a:ext cx="4443984" cy="3026664"/>
            </a:xfrm>
            <a:prstGeom prst="rect">
              <a:avLst/>
            </a:prstGeom>
          </p:spPr>
        </p:pic>
        <p:pic>
          <p:nvPicPr>
            <p:cNvPr id="6" name="Picture 5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32053" y="3552592"/>
              <a:ext cx="4443984" cy="3026664"/>
            </a:xfrm>
            <a:prstGeom prst="rect">
              <a:avLst/>
            </a:prstGeom>
          </p:spPr>
        </p:pic>
        <p:pic>
          <p:nvPicPr>
            <p:cNvPr id="7" name="Picture 6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28734" y="3552592"/>
              <a:ext cx="4443984" cy="3026664"/>
            </a:xfrm>
            <a:prstGeom prst="rect">
              <a:avLst/>
            </a:prstGeom>
          </p:spPr>
        </p:pic>
        <p:sp>
          <p:nvSpPr>
            <p:cNvPr id="2" name="Rectangle 1"/>
            <p:cNvSpPr/>
            <p:nvPr/>
          </p:nvSpPr>
          <p:spPr>
            <a:xfrm>
              <a:off x="457200" y="117566"/>
              <a:ext cx="10593977" cy="646169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32212" y="6242430"/>
            <a:ext cx="108682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9: Original western blots showing the concentration-dependent expression of CDK 4, 6; Cyclin A2 and Vinculin upon  treatment with MEP (PAL) on PC3 and </a:t>
            </a:r>
            <a:r>
              <a:rPr lang="en-US" b="1" dirty="0" smtClean="0">
                <a:cs typeface="Times New Roman" panose="02020603050405020304" pitchFamily="18" charset="0"/>
              </a:rPr>
              <a:t>DU145 cells.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91919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783770" y="130629"/>
            <a:ext cx="9326881" cy="5969725"/>
            <a:chOff x="783770" y="130629"/>
            <a:chExt cx="10110653" cy="6570616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87869" y="3520440"/>
              <a:ext cx="4443984" cy="3026664"/>
            </a:xfrm>
            <a:prstGeom prst="rect">
              <a:avLst/>
            </a:prstGeom>
          </p:spPr>
        </p:pic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7624" y="3674581"/>
              <a:ext cx="4443984" cy="3026664"/>
            </a:xfrm>
            <a:prstGeom prst="rect">
              <a:avLst/>
            </a:prstGeom>
          </p:spPr>
        </p:pic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7624" y="402336"/>
              <a:ext cx="4443984" cy="3026664"/>
            </a:xfrm>
            <a:prstGeom prst="rect">
              <a:avLst/>
            </a:prstGeom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87869" y="402336"/>
              <a:ext cx="4443984" cy="3026664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783770" y="130629"/>
              <a:ext cx="10110653" cy="657061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32212" y="6242430"/>
            <a:ext cx="108682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10: Original western blots showing the concentration-dependent expression of Cyclin D1 and time dependent expressions of IRE1 and ATF4 upon treatment with MEP (</a:t>
            </a:r>
            <a:r>
              <a:rPr lang="en-US" b="1" dirty="0">
                <a:cs typeface="Times New Roman" panose="02020603050405020304" pitchFamily="18" charset="0"/>
              </a:rPr>
              <a:t>PAL) </a:t>
            </a:r>
            <a:r>
              <a:rPr lang="en-US" b="1" dirty="0" smtClean="0">
                <a:cs typeface="Times New Roman" panose="02020603050405020304" pitchFamily="18" charset="0"/>
              </a:rPr>
              <a:t>on PC3 </a:t>
            </a:r>
            <a:r>
              <a:rPr lang="en-US" b="1" dirty="0">
                <a:cs typeface="Times New Roman" panose="02020603050405020304" pitchFamily="18" charset="0"/>
              </a:rPr>
              <a:t>and DU145 cells.</a:t>
            </a:r>
          </a:p>
        </p:txBody>
      </p:sp>
    </p:spTree>
    <p:extLst>
      <p:ext uri="{BB962C8B-B14F-4D97-AF65-F5344CB8AC3E}">
        <p14:creationId xmlns:p14="http://schemas.microsoft.com/office/powerpoint/2010/main" val="19058903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371600" y="195942"/>
            <a:ext cx="9222377" cy="5982789"/>
            <a:chOff x="966651" y="0"/>
            <a:chExt cx="9849395" cy="6583680"/>
          </a:xfrm>
        </p:grpSpPr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7856" y="145744"/>
              <a:ext cx="4443984" cy="3026664"/>
            </a:xfrm>
            <a:prstGeom prst="rect">
              <a:avLst/>
            </a:prstGeom>
          </p:spPr>
        </p:pic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60625" y="3362752"/>
              <a:ext cx="4443984" cy="3026664"/>
            </a:xfrm>
            <a:prstGeom prst="rect">
              <a:avLst/>
            </a:prstGeom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82617" y="145744"/>
              <a:ext cx="4443984" cy="3026664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966651" y="0"/>
              <a:ext cx="9849395" cy="658368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32212" y="6242430"/>
            <a:ext cx="108682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11: Original western blots showing the concentration-dependent expression of Caspase 3 and Caspase 9 upon treatment with MEP (</a:t>
            </a:r>
            <a:r>
              <a:rPr lang="en-US" b="1" dirty="0">
                <a:cs typeface="Times New Roman" panose="02020603050405020304" pitchFamily="18" charset="0"/>
              </a:rPr>
              <a:t>PAL) </a:t>
            </a:r>
            <a:r>
              <a:rPr lang="en-US" b="1" dirty="0" smtClean="0">
                <a:cs typeface="Times New Roman" panose="02020603050405020304" pitchFamily="18" charset="0"/>
              </a:rPr>
              <a:t>on PC3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753205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031966" y="0"/>
            <a:ext cx="10463348" cy="6457264"/>
            <a:chOff x="1031966" y="0"/>
            <a:chExt cx="10463348" cy="6457264"/>
          </a:xfrm>
        </p:grpSpPr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31031" y="149290"/>
              <a:ext cx="4443984" cy="302666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19348" y="149290"/>
              <a:ext cx="4070713" cy="304202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8539" y="3175954"/>
              <a:ext cx="4392330" cy="328131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1361" b="59857"/>
            <a:stretch/>
          </p:blipFill>
          <p:spPr>
            <a:xfrm>
              <a:off x="6628824" y="3574362"/>
              <a:ext cx="4552982" cy="1384675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1031966" y="0"/>
              <a:ext cx="10463348" cy="5878286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132212" y="6242430"/>
            <a:ext cx="108682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12: Original western blots showing the concentration-dependent expression of PARP and time-dependent expressions of XBP1, Calnexin, GRP78 and caspase 3 upon treatment with MEP (</a:t>
            </a:r>
            <a:r>
              <a:rPr lang="en-US" b="1" dirty="0">
                <a:cs typeface="Times New Roman" panose="02020603050405020304" pitchFamily="18" charset="0"/>
              </a:rPr>
              <a:t>PAL) </a:t>
            </a:r>
            <a:r>
              <a:rPr lang="en-US" b="1" dirty="0" smtClean="0">
                <a:cs typeface="Times New Roman" panose="02020603050405020304" pitchFamily="18" charset="0"/>
              </a:rPr>
              <a:t>on PC3 cells.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8053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34783" y="343472"/>
            <a:ext cx="4562856" cy="2807208"/>
          </a:xfrm>
          <a:prstGeom prst="rect">
            <a:avLst/>
          </a:prstGeom>
        </p:spPr>
      </p:pic>
      <p:pic>
        <p:nvPicPr>
          <p:cNvPr id="15" name="Picture 14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269292" y="343472"/>
            <a:ext cx="4562856" cy="2807208"/>
          </a:xfrm>
          <a:prstGeom prst="rect">
            <a:avLst/>
          </a:prstGeom>
        </p:spPr>
      </p:pic>
      <p:pic>
        <p:nvPicPr>
          <p:cNvPr id="19" name="Picture 18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34783" y="3427050"/>
            <a:ext cx="4562856" cy="2807208"/>
          </a:xfrm>
          <a:prstGeom prst="rect">
            <a:avLst/>
          </a:prstGeom>
        </p:spPr>
      </p:pic>
      <p:pic>
        <p:nvPicPr>
          <p:cNvPr id="20" name="Picture 1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269292" y="3464541"/>
            <a:ext cx="4562856" cy="280720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1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11485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901075" y="273133"/>
            <a:ext cx="4562856" cy="2807208"/>
          </a:xfrm>
          <a:prstGeom prst="rect">
            <a:avLst/>
          </a:prstGeom>
        </p:spPr>
      </p:pic>
      <p:pic>
        <p:nvPicPr>
          <p:cNvPr id="9" name="Picture 8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479216" y="273133"/>
            <a:ext cx="4562856" cy="2807208"/>
          </a:xfrm>
          <a:prstGeom prst="rect">
            <a:avLst/>
          </a:prstGeom>
        </p:spPr>
      </p:pic>
      <p:pic>
        <p:nvPicPr>
          <p:cNvPr id="10" name="Picture 9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901075" y="3316471"/>
            <a:ext cx="4562856" cy="2807208"/>
          </a:xfrm>
          <a:prstGeom prst="rect">
            <a:avLst/>
          </a:prstGeom>
        </p:spPr>
      </p:pic>
      <p:pic>
        <p:nvPicPr>
          <p:cNvPr id="11" name="Picture 10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479216" y="3316471"/>
            <a:ext cx="4562856" cy="28072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2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05187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887810" y="383666"/>
            <a:ext cx="4562856" cy="2807208"/>
          </a:xfrm>
          <a:prstGeom prst="rect">
            <a:avLst/>
          </a:prstGeom>
        </p:spPr>
      </p:pic>
      <p:pic>
        <p:nvPicPr>
          <p:cNvPr id="12" name="Picture 11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887810" y="3589127"/>
            <a:ext cx="4562856" cy="2807208"/>
          </a:xfrm>
          <a:prstGeom prst="rect">
            <a:avLst/>
          </a:prstGeom>
        </p:spPr>
      </p:pic>
      <p:pic>
        <p:nvPicPr>
          <p:cNvPr id="14" name="Picture 1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28122" y="3589127"/>
            <a:ext cx="4562856" cy="2807208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628122" y="383666"/>
            <a:ext cx="4562856" cy="2807208"/>
            <a:chOff x="628122" y="383666"/>
            <a:chExt cx="4562856" cy="2807208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8122" y="383666"/>
              <a:ext cx="4562856" cy="2807208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628122" y="393259"/>
              <a:ext cx="4433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887810" y="441642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28122" y="3718350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87810" y="3648064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2919" y="6425256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3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1878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65692" y="429561"/>
            <a:ext cx="4562856" cy="2807208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302217" y="429561"/>
            <a:ext cx="4562856" cy="2825496"/>
          </a:xfrm>
          <a:prstGeom prst="rect">
            <a:avLst/>
          </a:prstGeom>
        </p:spPr>
      </p:pic>
      <p:pic>
        <p:nvPicPr>
          <p:cNvPr id="5" name="Picture 4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65692" y="3372039"/>
            <a:ext cx="4562856" cy="2825496"/>
          </a:xfrm>
          <a:prstGeom prst="rect">
            <a:avLst/>
          </a:prstGeom>
        </p:spPr>
      </p:pic>
      <p:pic>
        <p:nvPicPr>
          <p:cNvPr id="13" name="Picture 12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302217" y="3439674"/>
            <a:ext cx="4562856" cy="28072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80522" y="429561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334594" y="429561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65692" y="3398032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366971" y="3551920"/>
            <a:ext cx="4433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4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52966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00825" y="269984"/>
            <a:ext cx="4562856" cy="2807208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605840" y="269984"/>
            <a:ext cx="4562856" cy="2807208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6605840" y="3245196"/>
            <a:ext cx="4562856" cy="2807208"/>
          </a:xfrm>
          <a:prstGeom prst="rect">
            <a:avLst/>
          </a:prstGeom>
        </p:spPr>
      </p:pic>
      <p:pic>
        <p:nvPicPr>
          <p:cNvPr id="11" name="Picture 10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00825" y="3245196"/>
            <a:ext cx="4562856" cy="28072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5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0532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762918" y="720359"/>
            <a:ext cx="4562856" cy="2807208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586943" y="720359"/>
            <a:ext cx="4562856" cy="280720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6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54549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810697" y="280692"/>
            <a:ext cx="4562856" cy="2807208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103565" y="280692"/>
            <a:ext cx="4562856" cy="2807208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810697" y="3413200"/>
            <a:ext cx="4562856" cy="2807208"/>
          </a:xfrm>
          <a:prstGeom prst="rect">
            <a:avLst/>
          </a:prstGeom>
        </p:spPr>
      </p:pic>
      <p:pic>
        <p:nvPicPr>
          <p:cNvPr id="5" name="Picture 4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103565" y="3413200"/>
            <a:ext cx="4562856" cy="280720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7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60061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949156" y="1316933"/>
            <a:ext cx="4562856" cy="2807208"/>
          </a:xfrm>
          <a:prstGeom prst="rect">
            <a:avLst/>
          </a:prstGeom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610918" y="1316933"/>
            <a:ext cx="4562856" cy="280720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8338" y="6363453"/>
            <a:ext cx="108682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cs typeface="Times New Roman" panose="02020603050405020304" pitchFamily="18" charset="0"/>
              </a:rPr>
              <a:t>Figure S8</a:t>
            </a:r>
            <a:endParaRPr lang="en-US" b="1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2598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5</TotalTime>
  <Words>161</Words>
  <Application>Microsoft Office PowerPoint</Application>
  <PresentationFormat>Widescreen</PresentationFormat>
  <Paragraphs>23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Saheed Afolabi</dc:creator>
  <cp:lastModifiedBy>Saheed Afolabi</cp:lastModifiedBy>
  <cp:revision>95</cp:revision>
  <dcterms:created xsi:type="dcterms:W3CDTF">2018-01-10T11:44:29Z</dcterms:created>
  <dcterms:modified xsi:type="dcterms:W3CDTF">2019-09-16T11:40:56Z</dcterms:modified>
</cp:coreProperties>
</file>